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1" r:id="rId4"/>
    <p:sldId id="262" r:id="rId5"/>
    <p:sldId id="263" r:id="rId6"/>
    <p:sldId id="264" r:id="rId7"/>
    <p:sldId id="265" r:id="rId8"/>
    <p:sldId id="259" r:id="rId9"/>
    <p:sldId id="260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456EA3-6BAE-4D13-87B6-CC74FFD34F8F}" v="1" dt="2023-02-22T12:19:47.7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7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yam Vizheh" userId="35f18e4e-fdf0-440f-865e-c16e1aae76af" providerId="ADAL" clId="{F4C07909-B347-43CB-9B81-D1521AB5E477}"/>
    <pc:docChg chg="undo custSel addSld delSld modSld modMainMaster">
      <pc:chgData name="Maryam Vizheh" userId="35f18e4e-fdf0-440f-865e-c16e1aae76af" providerId="ADAL" clId="{F4C07909-B347-43CB-9B81-D1521AB5E477}" dt="2022-10-03T23:50:01.426" v="163" actId="14100"/>
      <pc:docMkLst>
        <pc:docMk/>
      </pc:docMkLst>
      <pc:sldChg chg="modSp new mod">
        <pc:chgData name="Maryam Vizheh" userId="35f18e4e-fdf0-440f-865e-c16e1aae76af" providerId="ADAL" clId="{F4C07909-B347-43CB-9B81-D1521AB5E477}" dt="2022-10-03T09:35:21.263" v="26"/>
        <pc:sldMkLst>
          <pc:docMk/>
          <pc:sldMk cId="2927163868" sldId="256"/>
        </pc:sldMkLst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k cId="2927163868" sldId="256"/>
            <ac:spMk id="2" creationId="{D7AA7AEF-1135-460E-647F-5E6D0A1B9787}"/>
          </ac:spMkLst>
        </pc:spChg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k cId="2927163868" sldId="256"/>
            <ac:spMk id="3" creationId="{55ECDEAB-4E8F-62EE-DEB0-28D9B1ED2275}"/>
          </ac:spMkLst>
        </pc:spChg>
      </pc:sldChg>
      <pc:sldChg chg="addSp delSp modSp new mod modClrScheme chgLayout">
        <pc:chgData name="Maryam Vizheh" userId="35f18e4e-fdf0-440f-865e-c16e1aae76af" providerId="ADAL" clId="{F4C07909-B347-43CB-9B81-D1521AB5E477}" dt="2022-10-03T10:29:33.729" v="124" actId="1076"/>
        <pc:sldMkLst>
          <pc:docMk/>
          <pc:sldMk cId="3090361234" sldId="257"/>
        </pc:sldMkLst>
        <pc:spChg chg="del mod ord">
          <ac:chgData name="Maryam Vizheh" userId="35f18e4e-fdf0-440f-865e-c16e1aae76af" providerId="ADAL" clId="{F4C07909-B347-43CB-9B81-D1521AB5E477}" dt="2022-10-03T09:17:18.252" v="4" actId="700"/>
          <ac:spMkLst>
            <pc:docMk/>
            <pc:sldMk cId="3090361234" sldId="257"/>
            <ac:spMk id="2" creationId="{190A59E6-537A-BF78-C7DB-6241CF043074}"/>
          </ac:spMkLst>
        </pc:spChg>
        <pc:spChg chg="del">
          <ac:chgData name="Maryam Vizheh" userId="35f18e4e-fdf0-440f-865e-c16e1aae76af" providerId="ADAL" clId="{F4C07909-B347-43CB-9B81-D1521AB5E477}" dt="2022-10-03T09:17:18.252" v="4" actId="700"/>
          <ac:spMkLst>
            <pc:docMk/>
            <pc:sldMk cId="3090361234" sldId="257"/>
            <ac:spMk id="3" creationId="{6A5E8092-55E2-E406-39EF-4C404F820B99}"/>
          </ac:spMkLst>
        </pc:spChg>
        <pc:spChg chg="add mod ord">
          <ac:chgData name="Maryam Vizheh" userId="35f18e4e-fdf0-440f-865e-c16e1aae76af" providerId="ADAL" clId="{F4C07909-B347-43CB-9B81-D1521AB5E477}" dt="2022-10-03T10:29:30.045" v="123" actId="14100"/>
          <ac:spMkLst>
            <pc:docMk/>
            <pc:sldMk cId="3090361234" sldId="257"/>
            <ac:spMk id="4" creationId="{24DD9F24-D123-4606-CACA-A485D51D92A8}"/>
          </ac:spMkLst>
        </pc:spChg>
        <pc:picChg chg="add mod">
          <ac:chgData name="Maryam Vizheh" userId="35f18e4e-fdf0-440f-865e-c16e1aae76af" providerId="ADAL" clId="{F4C07909-B347-43CB-9B81-D1521AB5E477}" dt="2022-10-03T10:29:33.729" v="124" actId="1076"/>
          <ac:picMkLst>
            <pc:docMk/>
            <pc:sldMk cId="3090361234" sldId="257"/>
            <ac:picMk id="6" creationId="{9AF3101D-2C75-D91C-B914-C1E7B2DE7280}"/>
          </ac:picMkLst>
        </pc:picChg>
      </pc:sldChg>
      <pc:sldChg chg="addSp modSp new del mod">
        <pc:chgData name="Maryam Vizheh" userId="35f18e4e-fdf0-440f-865e-c16e1aae76af" providerId="ADAL" clId="{F4C07909-B347-43CB-9B81-D1521AB5E477}" dt="2022-10-03T10:23:15.461" v="105" actId="47"/>
        <pc:sldMkLst>
          <pc:docMk/>
          <pc:sldMk cId="486151426" sldId="258"/>
        </pc:sldMkLst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k cId="486151426" sldId="258"/>
            <ac:spMk id="2" creationId="{091EDC79-2CD2-D998-1280-A023B641C962}"/>
          </ac:spMkLst>
        </pc:spChg>
        <pc:picChg chg="add mod">
          <ac:chgData name="Maryam Vizheh" userId="35f18e4e-fdf0-440f-865e-c16e1aae76af" providerId="ADAL" clId="{F4C07909-B347-43CB-9B81-D1521AB5E477}" dt="2022-10-03T09:35:21.263" v="26"/>
          <ac:picMkLst>
            <pc:docMk/>
            <pc:sldMk cId="486151426" sldId="258"/>
            <ac:picMk id="4" creationId="{25A2A27D-DCA9-02D7-087E-A20ED956EACC}"/>
          </ac:picMkLst>
        </pc:picChg>
      </pc:sldChg>
      <pc:sldChg chg="addSp delSp modSp new mod">
        <pc:chgData name="Maryam Vizheh" userId="35f18e4e-fdf0-440f-865e-c16e1aae76af" providerId="ADAL" clId="{F4C07909-B347-43CB-9B81-D1521AB5E477}" dt="2022-10-03T10:30:22.465" v="140" actId="27636"/>
        <pc:sldMkLst>
          <pc:docMk/>
          <pc:sldMk cId="407340889" sldId="259"/>
        </pc:sldMkLst>
        <pc:spChg chg="mod">
          <ac:chgData name="Maryam Vizheh" userId="35f18e4e-fdf0-440f-865e-c16e1aae76af" providerId="ADAL" clId="{F4C07909-B347-43CB-9B81-D1521AB5E477}" dt="2022-10-03T10:30:22.465" v="140" actId="27636"/>
          <ac:spMkLst>
            <pc:docMk/>
            <pc:sldMk cId="407340889" sldId="259"/>
            <ac:spMk id="2" creationId="{1ECBB487-A7F1-0F8F-3BB9-79B8DD9AE87C}"/>
          </ac:spMkLst>
        </pc:spChg>
        <pc:picChg chg="add del mod">
          <ac:chgData name="Maryam Vizheh" userId="35f18e4e-fdf0-440f-865e-c16e1aae76af" providerId="ADAL" clId="{F4C07909-B347-43CB-9B81-D1521AB5E477}" dt="2022-10-03T09:28:38.176" v="17" actId="478"/>
          <ac:picMkLst>
            <pc:docMk/>
            <pc:sldMk cId="407340889" sldId="259"/>
            <ac:picMk id="4" creationId="{E2D24BA6-1FB8-269E-87D4-ABEE94BE76BF}"/>
          </ac:picMkLst>
        </pc:picChg>
        <pc:picChg chg="add del">
          <ac:chgData name="Maryam Vizheh" userId="35f18e4e-fdf0-440f-865e-c16e1aae76af" providerId="ADAL" clId="{F4C07909-B347-43CB-9B81-D1521AB5E477}" dt="2022-10-03T09:29:24.661" v="22" actId="478"/>
          <ac:picMkLst>
            <pc:docMk/>
            <pc:sldMk cId="407340889" sldId="259"/>
            <ac:picMk id="6" creationId="{6304B5EF-B345-341C-3E8E-34E4E7742C90}"/>
          </ac:picMkLst>
        </pc:picChg>
        <pc:picChg chg="add del">
          <ac:chgData name="Maryam Vizheh" userId="35f18e4e-fdf0-440f-865e-c16e1aae76af" providerId="ADAL" clId="{F4C07909-B347-43CB-9B81-D1521AB5E477}" dt="2022-10-03T09:30:23.613" v="24" actId="478"/>
          <ac:picMkLst>
            <pc:docMk/>
            <pc:sldMk cId="407340889" sldId="259"/>
            <ac:picMk id="8" creationId="{34707A0D-6160-7049-84D3-9CA2FAFEC4A3}"/>
          </ac:picMkLst>
        </pc:picChg>
        <pc:picChg chg="add mod">
          <ac:chgData name="Maryam Vizheh" userId="35f18e4e-fdf0-440f-865e-c16e1aae76af" providerId="ADAL" clId="{F4C07909-B347-43CB-9B81-D1521AB5E477}" dt="2022-10-03T10:30:19.213" v="138" actId="1076"/>
          <ac:picMkLst>
            <pc:docMk/>
            <pc:sldMk cId="407340889" sldId="259"/>
            <ac:picMk id="10" creationId="{11CB4197-FF2E-0C5D-596D-A6293F1ECA95}"/>
          </ac:picMkLst>
        </pc:picChg>
      </pc:sldChg>
      <pc:sldChg chg="addSp delSp modSp new mod">
        <pc:chgData name="Maryam Vizheh" userId="35f18e4e-fdf0-440f-865e-c16e1aae76af" providerId="ADAL" clId="{F4C07909-B347-43CB-9B81-D1521AB5E477}" dt="2022-10-03T10:30:31.462" v="142" actId="14100"/>
        <pc:sldMkLst>
          <pc:docMk/>
          <pc:sldMk cId="609540851" sldId="260"/>
        </pc:sldMkLst>
        <pc:spChg chg="mod">
          <ac:chgData name="Maryam Vizheh" userId="35f18e4e-fdf0-440f-865e-c16e1aae76af" providerId="ADAL" clId="{F4C07909-B347-43CB-9B81-D1521AB5E477}" dt="2022-10-03T10:29:02.854" v="119" actId="14100"/>
          <ac:spMkLst>
            <pc:docMk/>
            <pc:sldMk cId="609540851" sldId="260"/>
            <ac:spMk id="2" creationId="{8F0694B5-E4BD-99EA-EE97-108512C046F6}"/>
          </ac:spMkLst>
        </pc:spChg>
        <pc:picChg chg="add del">
          <ac:chgData name="Maryam Vizheh" userId="35f18e4e-fdf0-440f-865e-c16e1aae76af" providerId="ADAL" clId="{F4C07909-B347-43CB-9B81-D1521AB5E477}" dt="2022-10-03T09:29:22.702" v="21" actId="478"/>
          <ac:picMkLst>
            <pc:docMk/>
            <pc:sldMk cId="609540851" sldId="260"/>
            <ac:picMk id="4" creationId="{7D150FCF-E1C6-D704-450E-AA7FE870FC7C}"/>
          </ac:picMkLst>
        </pc:picChg>
        <pc:picChg chg="add mod">
          <ac:chgData name="Maryam Vizheh" userId="35f18e4e-fdf0-440f-865e-c16e1aae76af" providerId="ADAL" clId="{F4C07909-B347-43CB-9B81-D1521AB5E477}" dt="2022-10-03T10:30:31.462" v="142" actId="14100"/>
          <ac:picMkLst>
            <pc:docMk/>
            <pc:sldMk cId="609540851" sldId="260"/>
            <ac:picMk id="6" creationId="{CD96A1AA-0D01-693C-D0AB-B8F5D06E0ECA}"/>
          </ac:picMkLst>
        </pc:picChg>
      </pc:sldChg>
      <pc:sldChg chg="addSp delSp modSp new mod">
        <pc:chgData name="Maryam Vizheh" userId="35f18e4e-fdf0-440f-865e-c16e1aae76af" providerId="ADAL" clId="{F4C07909-B347-43CB-9B81-D1521AB5E477}" dt="2022-10-03T10:29:43.607" v="128" actId="1076"/>
        <pc:sldMkLst>
          <pc:docMk/>
          <pc:sldMk cId="550933116" sldId="261"/>
        </pc:sldMkLst>
        <pc:spChg chg="mod">
          <ac:chgData name="Maryam Vizheh" userId="35f18e4e-fdf0-440f-865e-c16e1aae76af" providerId="ADAL" clId="{F4C07909-B347-43CB-9B81-D1521AB5E477}" dt="2022-10-03T10:29:43.607" v="128" actId="1076"/>
          <ac:spMkLst>
            <pc:docMk/>
            <pc:sldMk cId="550933116" sldId="261"/>
            <ac:spMk id="2" creationId="{F76BB912-97C3-FA27-116A-B4F699E3363C}"/>
          </ac:spMkLst>
        </pc:spChg>
        <pc:picChg chg="add del">
          <ac:chgData name="Maryam Vizheh" userId="35f18e4e-fdf0-440f-865e-c16e1aae76af" providerId="ADAL" clId="{F4C07909-B347-43CB-9B81-D1521AB5E477}" dt="2022-10-03T09:55:33.458" v="39" actId="478"/>
          <ac:picMkLst>
            <pc:docMk/>
            <pc:sldMk cId="550933116" sldId="261"/>
            <ac:picMk id="4" creationId="{D2ED050C-125C-F3AE-7112-C89B07B49BBD}"/>
          </ac:picMkLst>
        </pc:picChg>
        <pc:picChg chg="add del">
          <ac:chgData name="Maryam Vizheh" userId="35f18e4e-fdf0-440f-865e-c16e1aae76af" providerId="ADAL" clId="{F4C07909-B347-43CB-9B81-D1521AB5E477}" dt="2022-10-03T09:55:31.972" v="38" actId="22"/>
          <ac:picMkLst>
            <pc:docMk/>
            <pc:sldMk cId="550933116" sldId="261"/>
            <ac:picMk id="6" creationId="{7E0314A0-FCEA-4ECC-FABD-7DF9B84DD224}"/>
          </ac:picMkLst>
        </pc:picChg>
        <pc:picChg chg="add del">
          <ac:chgData name="Maryam Vizheh" userId="35f18e4e-fdf0-440f-865e-c16e1aae76af" providerId="ADAL" clId="{F4C07909-B347-43CB-9B81-D1521AB5E477}" dt="2022-10-03T09:55:42.777" v="41" actId="478"/>
          <ac:picMkLst>
            <pc:docMk/>
            <pc:sldMk cId="550933116" sldId="261"/>
            <ac:picMk id="8" creationId="{2269530A-B2B1-C637-EF9B-BAF047BCF5D3}"/>
          </ac:picMkLst>
        </pc:picChg>
        <pc:picChg chg="add mod">
          <ac:chgData name="Maryam Vizheh" userId="35f18e4e-fdf0-440f-865e-c16e1aae76af" providerId="ADAL" clId="{F4C07909-B347-43CB-9B81-D1521AB5E477}" dt="2022-10-03T10:29:39.603" v="125" actId="1076"/>
          <ac:picMkLst>
            <pc:docMk/>
            <pc:sldMk cId="550933116" sldId="261"/>
            <ac:picMk id="10" creationId="{465FBB05-A06D-F6E0-9B03-8E27F251FD9F}"/>
          </ac:picMkLst>
        </pc:picChg>
      </pc:sldChg>
      <pc:sldChg chg="addSp modSp new mod">
        <pc:chgData name="Maryam Vizheh" userId="35f18e4e-fdf0-440f-865e-c16e1aae76af" providerId="ADAL" clId="{F4C07909-B347-43CB-9B81-D1521AB5E477}" dt="2022-10-03T10:29:54.602" v="132" actId="14100"/>
        <pc:sldMkLst>
          <pc:docMk/>
          <pc:sldMk cId="1207130705" sldId="262"/>
        </pc:sldMkLst>
        <pc:spChg chg="mod">
          <ac:chgData name="Maryam Vizheh" userId="35f18e4e-fdf0-440f-865e-c16e1aae76af" providerId="ADAL" clId="{F4C07909-B347-43CB-9B81-D1521AB5E477}" dt="2022-10-03T10:03:05.260" v="65" actId="14100"/>
          <ac:spMkLst>
            <pc:docMk/>
            <pc:sldMk cId="1207130705" sldId="262"/>
            <ac:spMk id="2" creationId="{D00A587A-DCD8-ECEB-1C2A-4BCB666F43F9}"/>
          </ac:spMkLst>
        </pc:spChg>
        <pc:picChg chg="add mod">
          <ac:chgData name="Maryam Vizheh" userId="35f18e4e-fdf0-440f-865e-c16e1aae76af" providerId="ADAL" clId="{F4C07909-B347-43CB-9B81-D1521AB5E477}" dt="2022-10-03T10:29:54.602" v="132" actId="14100"/>
          <ac:picMkLst>
            <pc:docMk/>
            <pc:sldMk cId="1207130705" sldId="262"/>
            <ac:picMk id="4" creationId="{FB6E1BB2-FA73-6286-10D9-FA1F1E781E74}"/>
          </ac:picMkLst>
        </pc:picChg>
      </pc:sldChg>
      <pc:sldChg chg="addSp modSp new mod">
        <pc:chgData name="Maryam Vizheh" userId="35f18e4e-fdf0-440f-865e-c16e1aae76af" providerId="ADAL" clId="{F4C07909-B347-43CB-9B81-D1521AB5E477}" dt="2022-10-03T10:30:05.381" v="135" actId="1076"/>
        <pc:sldMkLst>
          <pc:docMk/>
          <pc:sldMk cId="1521863869" sldId="263"/>
        </pc:sldMkLst>
        <pc:spChg chg="mod">
          <ac:chgData name="Maryam Vizheh" userId="35f18e4e-fdf0-440f-865e-c16e1aae76af" providerId="ADAL" clId="{F4C07909-B347-43CB-9B81-D1521AB5E477}" dt="2022-10-03T10:30:01.998" v="134" actId="1076"/>
          <ac:spMkLst>
            <pc:docMk/>
            <pc:sldMk cId="1521863869" sldId="263"/>
            <ac:spMk id="2" creationId="{F5FEE516-9510-0F4B-4F2C-888CA89C468C}"/>
          </ac:spMkLst>
        </pc:spChg>
        <pc:picChg chg="add mod">
          <ac:chgData name="Maryam Vizheh" userId="35f18e4e-fdf0-440f-865e-c16e1aae76af" providerId="ADAL" clId="{F4C07909-B347-43CB-9B81-D1521AB5E477}" dt="2022-10-03T10:30:05.381" v="135" actId="1076"/>
          <ac:picMkLst>
            <pc:docMk/>
            <pc:sldMk cId="1521863869" sldId="263"/>
            <ac:picMk id="4" creationId="{122D1165-6169-0836-1490-136DA70B3044}"/>
          </ac:picMkLst>
        </pc:picChg>
      </pc:sldChg>
      <pc:sldChg chg="addSp delSp modSp new mod">
        <pc:chgData name="Maryam Vizheh" userId="35f18e4e-fdf0-440f-865e-c16e1aae76af" providerId="ADAL" clId="{F4C07909-B347-43CB-9B81-D1521AB5E477}" dt="2022-10-03T23:50:01.426" v="163" actId="14100"/>
        <pc:sldMkLst>
          <pc:docMk/>
          <pc:sldMk cId="3923914792" sldId="264"/>
        </pc:sldMkLst>
        <pc:spChg chg="mod">
          <ac:chgData name="Maryam Vizheh" userId="35f18e4e-fdf0-440f-865e-c16e1aae76af" providerId="ADAL" clId="{F4C07909-B347-43CB-9B81-D1521AB5E477}" dt="2022-10-03T23:48:06.847" v="157" actId="20577"/>
          <ac:spMkLst>
            <pc:docMk/>
            <pc:sldMk cId="3923914792" sldId="264"/>
            <ac:spMk id="2" creationId="{F9FC3AF9-64CB-A414-3F95-232ECF1B8BF1}"/>
          </ac:spMkLst>
        </pc:spChg>
        <pc:picChg chg="add del">
          <ac:chgData name="Maryam Vizheh" userId="35f18e4e-fdf0-440f-865e-c16e1aae76af" providerId="ADAL" clId="{F4C07909-B347-43CB-9B81-D1521AB5E477}" dt="2022-10-03T10:05:05.005" v="71" actId="478"/>
          <ac:picMkLst>
            <pc:docMk/>
            <pc:sldMk cId="3923914792" sldId="264"/>
            <ac:picMk id="4" creationId="{50994149-85AD-4C1A-8A85-822F53A2BAAB}"/>
          </ac:picMkLst>
        </pc:picChg>
        <pc:picChg chg="add mod">
          <ac:chgData name="Maryam Vizheh" userId="35f18e4e-fdf0-440f-865e-c16e1aae76af" providerId="ADAL" clId="{F4C07909-B347-43CB-9B81-D1521AB5E477}" dt="2022-10-03T23:50:01.426" v="163" actId="14100"/>
          <ac:picMkLst>
            <pc:docMk/>
            <pc:sldMk cId="3923914792" sldId="264"/>
            <ac:picMk id="4" creationId="{DA3667E5-1BF1-0801-C571-46BCD3EDBC74}"/>
          </ac:picMkLst>
        </pc:picChg>
        <pc:picChg chg="add del mod">
          <ac:chgData name="Maryam Vizheh" userId="35f18e4e-fdf0-440f-865e-c16e1aae76af" providerId="ADAL" clId="{F4C07909-B347-43CB-9B81-D1521AB5E477}" dt="2022-10-03T23:49:48.466" v="158" actId="478"/>
          <ac:picMkLst>
            <pc:docMk/>
            <pc:sldMk cId="3923914792" sldId="264"/>
            <ac:picMk id="6" creationId="{A24B723F-E8AF-6C8E-9260-829A1476A05E}"/>
          </ac:picMkLst>
        </pc:picChg>
      </pc:sldChg>
      <pc:sldChg chg="addSp modSp new mod">
        <pc:chgData name="Maryam Vizheh" userId="35f18e4e-fdf0-440f-865e-c16e1aae76af" providerId="ADAL" clId="{F4C07909-B347-43CB-9B81-D1521AB5E477}" dt="2022-10-03T10:30:14.445" v="137" actId="1076"/>
        <pc:sldMkLst>
          <pc:docMk/>
          <pc:sldMk cId="2162717188" sldId="265"/>
        </pc:sldMkLst>
        <pc:spChg chg="mod">
          <ac:chgData name="Maryam Vizheh" userId="35f18e4e-fdf0-440f-865e-c16e1aae76af" providerId="ADAL" clId="{F4C07909-B347-43CB-9B81-D1521AB5E477}" dt="2022-10-03T10:30:14.445" v="137" actId="1076"/>
          <ac:spMkLst>
            <pc:docMk/>
            <pc:sldMk cId="2162717188" sldId="265"/>
            <ac:spMk id="2" creationId="{FA46C92B-C95F-5E56-7C1F-F223EC5217B0}"/>
          </ac:spMkLst>
        </pc:spChg>
        <pc:picChg chg="add mod">
          <ac:chgData name="Maryam Vizheh" userId="35f18e4e-fdf0-440f-865e-c16e1aae76af" providerId="ADAL" clId="{F4C07909-B347-43CB-9B81-D1521AB5E477}" dt="2022-10-03T10:22:29.349" v="100" actId="1076"/>
          <ac:picMkLst>
            <pc:docMk/>
            <pc:sldMk cId="2162717188" sldId="265"/>
            <ac:picMk id="4" creationId="{C8907F93-7C18-A743-4A92-67EFC2EFD8C1}"/>
          </ac:picMkLst>
        </pc:picChg>
      </pc:sldChg>
      <pc:sldMasterChg chg="modSp modSldLayout">
        <pc:chgData name="Maryam Vizheh" userId="35f18e4e-fdf0-440f-865e-c16e1aae76af" providerId="ADAL" clId="{F4C07909-B347-43CB-9B81-D1521AB5E477}" dt="2022-10-03T09:35:21.263" v="26"/>
        <pc:sldMasterMkLst>
          <pc:docMk/>
          <pc:sldMasterMk cId="362884652" sldId="2147483648"/>
        </pc:sldMasterMkLst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asterMk cId="362884652" sldId="2147483648"/>
            <ac:spMk id="2" creationId="{E00BBC5D-34A6-5263-60CC-18309F69DF2C}"/>
          </ac:spMkLst>
        </pc:spChg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asterMk cId="362884652" sldId="2147483648"/>
            <ac:spMk id="3" creationId="{A33A8934-A973-433C-714A-C258C5C7D75E}"/>
          </ac:spMkLst>
        </pc:spChg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asterMk cId="362884652" sldId="2147483648"/>
            <ac:spMk id="4" creationId="{9C06CF4F-2CF0-8BAD-4949-020020320FFF}"/>
          </ac:spMkLst>
        </pc:spChg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asterMk cId="362884652" sldId="2147483648"/>
            <ac:spMk id="5" creationId="{38F8B56E-43A2-5EE1-BA9D-32F4A9756144}"/>
          </ac:spMkLst>
        </pc:spChg>
        <pc:spChg chg="mod">
          <ac:chgData name="Maryam Vizheh" userId="35f18e4e-fdf0-440f-865e-c16e1aae76af" providerId="ADAL" clId="{F4C07909-B347-43CB-9B81-D1521AB5E477}" dt="2022-10-03T09:35:21.263" v="26"/>
          <ac:spMkLst>
            <pc:docMk/>
            <pc:sldMasterMk cId="362884652" sldId="2147483648"/>
            <ac:spMk id="6" creationId="{21E3D6F7-6D84-22E4-B139-0BB2D2660D3C}"/>
          </ac:spMkLst>
        </pc:sp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1934014592" sldId="2147483649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1934014592" sldId="2147483649"/>
              <ac:spMk id="2" creationId="{3665AD02-14D1-C775-8A14-3EB7B0244710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1934014592" sldId="2147483649"/>
              <ac:spMk id="3" creationId="{BD4EA61E-6169-D4C2-CDAC-C6628FC6A818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2175455825" sldId="2147483651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175455825" sldId="2147483651"/>
              <ac:spMk id="2" creationId="{BB50850F-3286-1FBB-50CD-23326FC33380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175455825" sldId="2147483651"/>
              <ac:spMk id="3" creationId="{5BD75F89-19F4-C56F-5A8C-A28D87D306F5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3320336753" sldId="2147483652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3320336753" sldId="2147483652"/>
              <ac:spMk id="3" creationId="{B35FE084-649A-059B-D24E-CC28EE0A0E12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3320336753" sldId="2147483652"/>
              <ac:spMk id="4" creationId="{19201ED0-34C1-7238-CDAA-314B6096893F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2332017105" sldId="2147483653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332017105" sldId="2147483653"/>
              <ac:spMk id="2" creationId="{B63E34A6-8E7F-DBC6-25B4-F40B573B8E90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332017105" sldId="2147483653"/>
              <ac:spMk id="3" creationId="{68D04554-37EA-3B3F-0B6B-CB2BBE47AE7B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332017105" sldId="2147483653"/>
              <ac:spMk id="4" creationId="{8EB79EBD-3DC4-31EA-544C-54E5F8DF3BEF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332017105" sldId="2147483653"/>
              <ac:spMk id="5" creationId="{FDB757EF-E3E6-EAD4-8F8F-90BD307007A7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2332017105" sldId="2147483653"/>
              <ac:spMk id="6" creationId="{DEC3E3C4-9BB8-DC9C-3CCA-F118C1190AB1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686445178" sldId="2147483656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686445178" sldId="2147483656"/>
              <ac:spMk id="2" creationId="{21D9C664-1137-7699-E41B-29DBB19490A6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686445178" sldId="2147483656"/>
              <ac:spMk id="3" creationId="{314B87C8-9020-B02E-4764-DC433F130DCD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686445178" sldId="2147483656"/>
              <ac:spMk id="4" creationId="{EC5F1B6D-B79F-2848-A100-BC0429EE5452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842442142" sldId="2147483657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842442142" sldId="2147483657"/>
              <ac:spMk id="2" creationId="{F3B2FFEE-E240-940D-D177-2FF43AED169D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842442142" sldId="2147483657"/>
              <ac:spMk id="3" creationId="{67288BB2-4C1E-4993-8C2D-380AFC4BD297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842442142" sldId="2147483657"/>
              <ac:spMk id="4" creationId="{27D955B1-3BE0-B1F8-00C8-D35EED6426CE}"/>
            </ac:spMkLst>
          </pc:spChg>
        </pc:sldLayoutChg>
        <pc:sldLayoutChg chg="modSp">
          <pc:chgData name="Maryam Vizheh" userId="35f18e4e-fdf0-440f-865e-c16e1aae76af" providerId="ADAL" clId="{F4C07909-B347-43CB-9B81-D1521AB5E477}" dt="2022-10-03T09:35:21.263" v="26"/>
          <pc:sldLayoutMkLst>
            <pc:docMk/>
            <pc:sldMasterMk cId="362884652" sldId="2147483648"/>
            <pc:sldLayoutMk cId="3473757422" sldId="2147483659"/>
          </pc:sldLayoutMkLst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3473757422" sldId="2147483659"/>
              <ac:spMk id="2" creationId="{2036245E-7E0F-CB4E-E809-0810D863366A}"/>
            </ac:spMkLst>
          </pc:spChg>
          <pc:spChg chg="mod">
            <ac:chgData name="Maryam Vizheh" userId="35f18e4e-fdf0-440f-865e-c16e1aae76af" providerId="ADAL" clId="{F4C07909-B347-43CB-9B81-D1521AB5E477}" dt="2022-10-03T09:35:21.263" v="26"/>
            <ac:spMkLst>
              <pc:docMk/>
              <pc:sldMasterMk cId="362884652" sldId="2147483648"/>
              <pc:sldLayoutMk cId="3473757422" sldId="2147483659"/>
              <ac:spMk id="3" creationId="{BAC13E8E-42A2-4484-8B7C-2362268625E1}"/>
            </ac:spMkLst>
          </pc:spChg>
        </pc:sldLayoutChg>
      </pc:sldMasterChg>
    </pc:docChg>
  </pc:docChgLst>
  <pc:docChgLst>
    <pc:chgData name="Maryam Vizheh" userId="35f18e4e-fdf0-440f-865e-c16e1aae76af" providerId="ADAL" clId="{6595D126-F2B5-4027-B5D4-4996D8A7BCAA}"/>
    <pc:docChg chg="modSld">
      <pc:chgData name="Maryam Vizheh" userId="35f18e4e-fdf0-440f-865e-c16e1aae76af" providerId="ADAL" clId="{6595D126-F2B5-4027-B5D4-4996D8A7BCAA}" dt="2022-12-14T05:51:33.927" v="9" actId="20577"/>
      <pc:docMkLst>
        <pc:docMk/>
      </pc:docMkLst>
      <pc:sldChg chg="modSp mod">
        <pc:chgData name="Maryam Vizheh" userId="35f18e4e-fdf0-440f-865e-c16e1aae76af" providerId="ADAL" clId="{6595D126-F2B5-4027-B5D4-4996D8A7BCAA}" dt="2022-12-14T05:51:33.927" v="9" actId="20577"/>
        <pc:sldMkLst>
          <pc:docMk/>
          <pc:sldMk cId="2927163868" sldId="256"/>
        </pc:sldMkLst>
        <pc:spChg chg="mod">
          <ac:chgData name="Maryam Vizheh" userId="35f18e4e-fdf0-440f-865e-c16e1aae76af" providerId="ADAL" clId="{6595D126-F2B5-4027-B5D4-4996D8A7BCAA}" dt="2022-12-14T05:51:33.927" v="9" actId="20577"/>
          <ac:spMkLst>
            <pc:docMk/>
            <pc:sldMk cId="2927163868" sldId="256"/>
            <ac:spMk id="2" creationId="{D7AA7AEF-1135-460E-647F-5E6D0A1B9787}"/>
          </ac:spMkLst>
        </pc:spChg>
      </pc:sldChg>
    </pc:docChg>
  </pc:docChgLst>
  <pc:docChgLst>
    <pc:chgData name="Maryam Vizheh" userId="35f18e4e-fdf0-440f-865e-c16e1aae76af" providerId="ADAL" clId="{A47CB946-9DB8-4D26-8CE6-5FA78A676629}"/>
    <pc:docChg chg="custSel modSld">
      <pc:chgData name="Maryam Vizheh" userId="35f18e4e-fdf0-440f-865e-c16e1aae76af" providerId="ADAL" clId="{A47CB946-9DB8-4D26-8CE6-5FA78A676629}" dt="2022-10-28T00:04:38.048" v="106" actId="20577"/>
      <pc:docMkLst>
        <pc:docMk/>
      </pc:docMkLst>
      <pc:sldChg chg="modSp mod">
        <pc:chgData name="Maryam Vizheh" userId="35f18e4e-fdf0-440f-865e-c16e1aae76af" providerId="ADAL" clId="{A47CB946-9DB8-4D26-8CE6-5FA78A676629}" dt="2022-10-28T00:04:38.048" v="106" actId="20577"/>
        <pc:sldMkLst>
          <pc:docMk/>
          <pc:sldMk cId="2927163868" sldId="256"/>
        </pc:sldMkLst>
        <pc:spChg chg="mod">
          <ac:chgData name="Maryam Vizheh" userId="35f18e4e-fdf0-440f-865e-c16e1aae76af" providerId="ADAL" clId="{A47CB946-9DB8-4D26-8CE6-5FA78A676629}" dt="2022-10-28T00:04:38.048" v="106" actId="20577"/>
          <ac:spMkLst>
            <pc:docMk/>
            <pc:sldMk cId="2927163868" sldId="256"/>
            <ac:spMk id="3" creationId="{55ECDEAB-4E8F-62EE-DEB0-28D9B1ED2275}"/>
          </ac:spMkLst>
        </pc:spChg>
      </pc:sldChg>
      <pc:sldChg chg="addSp delSp modSp mod">
        <pc:chgData name="Maryam Vizheh" userId="35f18e4e-fdf0-440f-865e-c16e1aae76af" providerId="ADAL" clId="{A47CB946-9DB8-4D26-8CE6-5FA78A676629}" dt="2022-10-27T22:43:05.650" v="5" actId="1076"/>
        <pc:sldMkLst>
          <pc:docMk/>
          <pc:sldMk cId="550933116" sldId="261"/>
        </pc:sldMkLst>
        <pc:spChg chg="mod">
          <ac:chgData name="Maryam Vizheh" userId="35f18e4e-fdf0-440f-865e-c16e1aae76af" providerId="ADAL" clId="{A47CB946-9DB8-4D26-8CE6-5FA78A676629}" dt="2022-10-27T22:43:05.650" v="5" actId="1076"/>
          <ac:spMkLst>
            <pc:docMk/>
            <pc:sldMk cId="550933116" sldId="261"/>
            <ac:spMk id="2" creationId="{F76BB912-97C3-FA27-116A-B4F699E3363C}"/>
          </ac:spMkLst>
        </pc:spChg>
        <pc:picChg chg="add mod">
          <ac:chgData name="Maryam Vizheh" userId="35f18e4e-fdf0-440f-865e-c16e1aae76af" providerId="ADAL" clId="{A47CB946-9DB8-4D26-8CE6-5FA78A676629}" dt="2022-10-27T22:43:00.476" v="2" actId="1076"/>
          <ac:picMkLst>
            <pc:docMk/>
            <pc:sldMk cId="550933116" sldId="261"/>
            <ac:picMk id="4" creationId="{388FCC41-A6F4-9813-E8BF-1198A51BD541}"/>
          </ac:picMkLst>
        </pc:picChg>
        <pc:picChg chg="del">
          <ac:chgData name="Maryam Vizheh" userId="35f18e4e-fdf0-440f-865e-c16e1aae76af" providerId="ADAL" clId="{A47CB946-9DB8-4D26-8CE6-5FA78A676629}" dt="2022-10-27T22:42:47.198" v="0" actId="478"/>
          <ac:picMkLst>
            <pc:docMk/>
            <pc:sldMk cId="550933116" sldId="261"/>
            <ac:picMk id="10" creationId="{465FBB05-A06D-F6E0-9B03-8E27F251FD9F}"/>
          </ac:picMkLst>
        </pc:picChg>
      </pc:sldChg>
      <pc:sldChg chg="addSp delSp modSp mod">
        <pc:chgData name="Maryam Vizheh" userId="35f18e4e-fdf0-440f-865e-c16e1aae76af" providerId="ADAL" clId="{A47CB946-9DB8-4D26-8CE6-5FA78A676629}" dt="2022-10-27T22:46:01.414" v="13" actId="20577"/>
        <pc:sldMkLst>
          <pc:docMk/>
          <pc:sldMk cId="3923914792" sldId="264"/>
        </pc:sldMkLst>
        <pc:spChg chg="mod">
          <ac:chgData name="Maryam Vizheh" userId="35f18e4e-fdf0-440f-865e-c16e1aae76af" providerId="ADAL" clId="{A47CB946-9DB8-4D26-8CE6-5FA78A676629}" dt="2022-10-27T22:46:01.414" v="13" actId="20577"/>
          <ac:spMkLst>
            <pc:docMk/>
            <pc:sldMk cId="3923914792" sldId="264"/>
            <ac:spMk id="2" creationId="{F9FC3AF9-64CB-A414-3F95-232ECF1B8BF1}"/>
          </ac:spMkLst>
        </pc:spChg>
        <pc:picChg chg="del">
          <ac:chgData name="Maryam Vizheh" userId="35f18e4e-fdf0-440f-865e-c16e1aae76af" providerId="ADAL" clId="{A47CB946-9DB8-4D26-8CE6-5FA78A676629}" dt="2022-10-27T22:45:39.949" v="6" actId="478"/>
          <ac:picMkLst>
            <pc:docMk/>
            <pc:sldMk cId="3923914792" sldId="264"/>
            <ac:picMk id="4" creationId="{DA3667E5-1BF1-0801-C571-46BCD3EDBC74}"/>
          </ac:picMkLst>
        </pc:picChg>
        <pc:picChg chg="add mod">
          <ac:chgData name="Maryam Vizheh" userId="35f18e4e-fdf0-440f-865e-c16e1aae76af" providerId="ADAL" clId="{A47CB946-9DB8-4D26-8CE6-5FA78A676629}" dt="2022-10-27T22:45:51.897" v="9" actId="1076"/>
          <ac:picMkLst>
            <pc:docMk/>
            <pc:sldMk cId="3923914792" sldId="264"/>
            <ac:picMk id="5" creationId="{5A934ADD-F609-F553-C3A0-5F6C10B3EA1D}"/>
          </ac:picMkLst>
        </pc:picChg>
      </pc:sldChg>
    </pc:docChg>
  </pc:docChgLst>
  <pc:docChgLst>
    <pc:chgData name="Maryam Vizheh" userId="35f18e4e-fdf0-440f-865e-c16e1aae76af" providerId="ADAL" clId="{3D4FC9FD-5B22-4007-AE11-03B0EEE6037B}"/>
    <pc:docChg chg="undo custSel modSld">
      <pc:chgData name="Maryam Vizheh" userId="35f18e4e-fdf0-440f-865e-c16e1aae76af" providerId="ADAL" clId="{3D4FC9FD-5B22-4007-AE11-03B0EEE6037B}" dt="2022-11-03T09:09:04.075" v="121" actId="1076"/>
      <pc:docMkLst>
        <pc:docMk/>
      </pc:docMkLst>
      <pc:sldChg chg="modSp mod">
        <pc:chgData name="Maryam Vizheh" userId="35f18e4e-fdf0-440f-865e-c16e1aae76af" providerId="ADAL" clId="{3D4FC9FD-5B22-4007-AE11-03B0EEE6037B}" dt="2022-11-03T06:58:06.636" v="2" actId="27636"/>
        <pc:sldMkLst>
          <pc:docMk/>
          <pc:sldMk cId="2927163868" sldId="256"/>
        </pc:sldMkLst>
        <pc:spChg chg="mod">
          <ac:chgData name="Maryam Vizheh" userId="35f18e4e-fdf0-440f-865e-c16e1aae76af" providerId="ADAL" clId="{3D4FC9FD-5B22-4007-AE11-03B0EEE6037B}" dt="2022-11-03T06:58:06.636" v="2" actId="27636"/>
          <ac:spMkLst>
            <pc:docMk/>
            <pc:sldMk cId="2927163868" sldId="256"/>
            <ac:spMk id="3" creationId="{55ECDEAB-4E8F-62EE-DEB0-28D9B1ED2275}"/>
          </ac:spMkLst>
        </pc:spChg>
      </pc:sldChg>
      <pc:sldChg chg="addSp delSp modSp mod">
        <pc:chgData name="Maryam Vizheh" userId="35f18e4e-fdf0-440f-865e-c16e1aae76af" providerId="ADAL" clId="{3D4FC9FD-5B22-4007-AE11-03B0EEE6037B}" dt="2022-11-03T09:08:53.058" v="118" actId="14100"/>
        <pc:sldMkLst>
          <pc:docMk/>
          <pc:sldMk cId="3090361234" sldId="257"/>
        </pc:sldMkLst>
        <pc:spChg chg="mod">
          <ac:chgData name="Maryam Vizheh" userId="35f18e4e-fdf0-440f-865e-c16e1aae76af" providerId="ADAL" clId="{3D4FC9FD-5B22-4007-AE11-03B0EEE6037B}" dt="2022-11-03T09:08:53.058" v="118" actId="14100"/>
          <ac:spMkLst>
            <pc:docMk/>
            <pc:sldMk cId="3090361234" sldId="257"/>
            <ac:spMk id="4" creationId="{24DD9F24-D123-4606-CACA-A485D51D92A8}"/>
          </ac:spMkLst>
        </pc:spChg>
        <pc:picChg chg="add del mod">
          <ac:chgData name="Maryam Vizheh" userId="35f18e4e-fdf0-440f-865e-c16e1aae76af" providerId="ADAL" clId="{3D4FC9FD-5B22-4007-AE11-03B0EEE6037B}" dt="2022-11-03T06:59:18.350" v="13" actId="478"/>
          <ac:picMkLst>
            <pc:docMk/>
            <pc:sldMk cId="3090361234" sldId="257"/>
            <ac:picMk id="3" creationId="{451C97FE-5603-D73D-70C9-CFAC38FD049B}"/>
          </ac:picMkLst>
        </pc:picChg>
        <pc:picChg chg="del">
          <ac:chgData name="Maryam Vizheh" userId="35f18e4e-fdf0-440f-865e-c16e1aae76af" providerId="ADAL" clId="{3D4FC9FD-5B22-4007-AE11-03B0EEE6037B}" dt="2022-11-03T06:58:11.252" v="3" actId="478"/>
          <ac:picMkLst>
            <pc:docMk/>
            <pc:sldMk cId="3090361234" sldId="257"/>
            <ac:picMk id="6" creationId="{9AF3101D-2C75-D91C-B914-C1E7B2DE7280}"/>
          </ac:picMkLst>
        </pc:picChg>
        <pc:picChg chg="add del mod">
          <ac:chgData name="Maryam Vizheh" userId="35f18e4e-fdf0-440f-865e-c16e1aae76af" providerId="ADAL" clId="{3D4FC9FD-5B22-4007-AE11-03B0EEE6037B}" dt="2022-11-03T06:59:49.716" v="18" actId="478"/>
          <ac:picMkLst>
            <pc:docMk/>
            <pc:sldMk cId="3090361234" sldId="257"/>
            <ac:picMk id="7" creationId="{6C0276DB-D0D0-021F-5E7C-86CD8CBBDDF1}"/>
          </ac:picMkLst>
        </pc:picChg>
        <pc:picChg chg="add del mod">
          <ac:chgData name="Maryam Vizheh" userId="35f18e4e-fdf0-440f-865e-c16e1aae76af" providerId="ADAL" clId="{3D4FC9FD-5B22-4007-AE11-03B0EEE6037B}" dt="2022-11-03T07:49:37.793" v="29" actId="478"/>
          <ac:picMkLst>
            <pc:docMk/>
            <pc:sldMk cId="3090361234" sldId="257"/>
            <ac:picMk id="9" creationId="{EA26C56B-037C-C57E-66CC-42C012740D2A}"/>
          </ac:picMkLst>
        </pc:picChg>
        <pc:picChg chg="add del mod">
          <ac:chgData name="Maryam Vizheh" userId="35f18e4e-fdf0-440f-865e-c16e1aae76af" providerId="ADAL" clId="{3D4FC9FD-5B22-4007-AE11-03B0EEE6037B}" dt="2022-11-03T07:50:07.779" v="34" actId="478"/>
          <ac:picMkLst>
            <pc:docMk/>
            <pc:sldMk cId="3090361234" sldId="257"/>
            <ac:picMk id="11" creationId="{83B05841-92DF-2FBA-EEFD-27E4192F5E6E}"/>
          </ac:picMkLst>
        </pc:picChg>
        <pc:picChg chg="add mod">
          <ac:chgData name="Maryam Vizheh" userId="35f18e4e-fdf0-440f-865e-c16e1aae76af" providerId="ADAL" clId="{3D4FC9FD-5B22-4007-AE11-03B0EEE6037B}" dt="2022-11-03T09:08:48.545" v="116" actId="1076"/>
          <ac:picMkLst>
            <pc:docMk/>
            <pc:sldMk cId="3090361234" sldId="257"/>
            <ac:picMk id="13" creationId="{CC13FA54-C5AA-EA8D-9E05-39FA691CDC96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39:01.061" v="99" actId="22"/>
        <pc:sldMkLst>
          <pc:docMk/>
          <pc:sldMk cId="407340889" sldId="259"/>
        </pc:sldMkLst>
        <pc:picChg chg="add del mod">
          <ac:chgData name="Maryam Vizheh" userId="35f18e4e-fdf0-440f-865e-c16e1aae76af" providerId="ADAL" clId="{3D4FC9FD-5B22-4007-AE11-03B0EEE6037B}" dt="2022-11-03T08:38:54.525" v="98" actId="478"/>
          <ac:picMkLst>
            <pc:docMk/>
            <pc:sldMk cId="407340889" sldId="259"/>
            <ac:picMk id="4" creationId="{FE523C5A-C453-D8EA-45A8-F53016146F6E}"/>
          </ac:picMkLst>
        </pc:picChg>
        <pc:picChg chg="add">
          <ac:chgData name="Maryam Vizheh" userId="35f18e4e-fdf0-440f-865e-c16e1aae76af" providerId="ADAL" clId="{3D4FC9FD-5B22-4007-AE11-03B0EEE6037B}" dt="2022-11-03T08:39:01.061" v="99" actId="22"/>
          <ac:picMkLst>
            <pc:docMk/>
            <pc:sldMk cId="407340889" sldId="259"/>
            <ac:picMk id="6" creationId="{0BD810BE-C7FB-1EC8-120F-A29B3D105FAE}"/>
          </ac:picMkLst>
        </pc:picChg>
        <pc:picChg chg="del">
          <ac:chgData name="Maryam Vizheh" userId="35f18e4e-fdf0-440f-865e-c16e1aae76af" providerId="ADAL" clId="{3D4FC9FD-5B22-4007-AE11-03B0EEE6037B}" dt="2022-11-03T07:00:17.004" v="26" actId="478"/>
          <ac:picMkLst>
            <pc:docMk/>
            <pc:sldMk cId="407340889" sldId="259"/>
            <ac:picMk id="10" creationId="{11CB4197-FF2E-0C5D-596D-A6293F1ECA95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30:11.300" v="87" actId="14100"/>
        <pc:sldMkLst>
          <pc:docMk/>
          <pc:sldMk cId="609540851" sldId="260"/>
        </pc:sldMkLst>
        <pc:picChg chg="add mod">
          <ac:chgData name="Maryam Vizheh" userId="35f18e4e-fdf0-440f-865e-c16e1aae76af" providerId="ADAL" clId="{3D4FC9FD-5B22-4007-AE11-03B0EEE6037B}" dt="2022-11-03T08:30:11.300" v="87" actId="14100"/>
          <ac:picMkLst>
            <pc:docMk/>
            <pc:sldMk cId="609540851" sldId="260"/>
            <ac:picMk id="4" creationId="{6575345C-D148-D3EA-1FB9-76FA79A77642}"/>
          </ac:picMkLst>
        </pc:picChg>
        <pc:picChg chg="del">
          <ac:chgData name="Maryam Vizheh" userId="35f18e4e-fdf0-440f-865e-c16e1aae76af" providerId="ADAL" clId="{3D4FC9FD-5B22-4007-AE11-03B0EEE6037B}" dt="2022-11-03T07:00:18.430" v="27" actId="478"/>
          <ac:picMkLst>
            <pc:docMk/>
            <pc:sldMk cId="609540851" sldId="260"/>
            <ac:picMk id="6" creationId="{CD96A1AA-0D01-693C-D0AB-B8F5D06E0ECA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9:09:04.075" v="121" actId="1076"/>
        <pc:sldMkLst>
          <pc:docMk/>
          <pc:sldMk cId="550933116" sldId="261"/>
        </pc:sldMkLst>
        <pc:spChg chg="mod">
          <ac:chgData name="Maryam Vizheh" userId="35f18e4e-fdf0-440f-865e-c16e1aae76af" providerId="ADAL" clId="{3D4FC9FD-5B22-4007-AE11-03B0EEE6037B}" dt="2022-11-03T09:09:04.075" v="121" actId="1076"/>
          <ac:spMkLst>
            <pc:docMk/>
            <pc:sldMk cId="550933116" sldId="261"/>
            <ac:spMk id="2" creationId="{F76BB912-97C3-FA27-116A-B4F699E3363C}"/>
          </ac:spMkLst>
        </pc:spChg>
        <pc:picChg chg="del">
          <ac:chgData name="Maryam Vizheh" userId="35f18e4e-fdf0-440f-865e-c16e1aae76af" providerId="ADAL" clId="{3D4FC9FD-5B22-4007-AE11-03B0EEE6037B}" dt="2022-11-03T07:00:03.284" v="21" actId="478"/>
          <ac:picMkLst>
            <pc:docMk/>
            <pc:sldMk cId="550933116" sldId="261"/>
            <ac:picMk id="4" creationId="{388FCC41-A6F4-9813-E8BF-1198A51BD541}"/>
          </ac:picMkLst>
        </pc:picChg>
        <pc:picChg chg="add mod">
          <ac:chgData name="Maryam Vizheh" userId="35f18e4e-fdf0-440f-865e-c16e1aae76af" providerId="ADAL" clId="{3D4FC9FD-5B22-4007-AE11-03B0EEE6037B}" dt="2022-11-03T09:09:00.026" v="119" actId="1076"/>
          <ac:picMkLst>
            <pc:docMk/>
            <pc:sldMk cId="550933116" sldId="261"/>
            <ac:picMk id="5" creationId="{44E9E6D5-8956-31C8-7303-38173CD8B442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02:44.094" v="43" actId="478"/>
        <pc:sldMkLst>
          <pc:docMk/>
          <pc:sldMk cId="1207130705" sldId="262"/>
        </pc:sldMkLst>
        <pc:picChg chg="del">
          <ac:chgData name="Maryam Vizheh" userId="35f18e4e-fdf0-440f-865e-c16e1aae76af" providerId="ADAL" clId="{3D4FC9FD-5B22-4007-AE11-03B0EEE6037B}" dt="2022-11-03T07:00:04.936" v="22" actId="478"/>
          <ac:picMkLst>
            <pc:docMk/>
            <pc:sldMk cId="1207130705" sldId="262"/>
            <ac:picMk id="4" creationId="{FB6E1BB2-FA73-6286-10D9-FA1F1E781E74}"/>
          </ac:picMkLst>
        </pc:picChg>
        <pc:picChg chg="add mod">
          <ac:chgData name="Maryam Vizheh" userId="35f18e4e-fdf0-440f-865e-c16e1aae76af" providerId="ADAL" clId="{3D4FC9FD-5B22-4007-AE11-03B0EEE6037B}" dt="2022-11-03T08:02:20.765" v="40" actId="1076"/>
          <ac:picMkLst>
            <pc:docMk/>
            <pc:sldMk cId="1207130705" sldId="262"/>
            <ac:picMk id="5" creationId="{DA2CDD76-3C1D-A5F3-141A-070C3729A58A}"/>
          </ac:picMkLst>
        </pc:picChg>
        <pc:picChg chg="add del mod">
          <ac:chgData name="Maryam Vizheh" userId="35f18e4e-fdf0-440f-865e-c16e1aae76af" providerId="ADAL" clId="{3D4FC9FD-5B22-4007-AE11-03B0EEE6037B}" dt="2022-11-03T08:02:44.094" v="43" actId="478"/>
          <ac:picMkLst>
            <pc:docMk/>
            <pc:sldMk cId="1207130705" sldId="262"/>
            <ac:picMk id="7" creationId="{E1FE8992-569E-BAAA-B655-F39AB476479B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55:18.041" v="115" actId="14100"/>
        <pc:sldMkLst>
          <pc:docMk/>
          <pc:sldMk cId="1521863869" sldId="263"/>
        </pc:sldMkLst>
        <pc:spChg chg="mod">
          <ac:chgData name="Maryam Vizheh" userId="35f18e4e-fdf0-440f-865e-c16e1aae76af" providerId="ADAL" clId="{3D4FC9FD-5B22-4007-AE11-03B0EEE6037B}" dt="2022-11-03T08:04:30.098" v="53" actId="27636"/>
          <ac:spMkLst>
            <pc:docMk/>
            <pc:sldMk cId="1521863869" sldId="263"/>
            <ac:spMk id="2" creationId="{F5FEE516-9510-0F4B-4F2C-888CA89C468C}"/>
          </ac:spMkLst>
        </pc:spChg>
        <pc:picChg chg="del">
          <ac:chgData name="Maryam Vizheh" userId="35f18e4e-fdf0-440f-865e-c16e1aae76af" providerId="ADAL" clId="{3D4FC9FD-5B22-4007-AE11-03B0EEE6037B}" dt="2022-11-03T07:00:12.046" v="23" actId="478"/>
          <ac:picMkLst>
            <pc:docMk/>
            <pc:sldMk cId="1521863869" sldId="263"/>
            <ac:picMk id="4" creationId="{122D1165-6169-0836-1490-136DA70B3044}"/>
          </ac:picMkLst>
        </pc:picChg>
        <pc:picChg chg="add del mod">
          <ac:chgData name="Maryam Vizheh" userId="35f18e4e-fdf0-440f-865e-c16e1aae76af" providerId="ADAL" clId="{3D4FC9FD-5B22-4007-AE11-03B0EEE6037B}" dt="2022-11-03T08:04:01.068" v="48" actId="478"/>
          <ac:picMkLst>
            <pc:docMk/>
            <pc:sldMk cId="1521863869" sldId="263"/>
            <ac:picMk id="5" creationId="{936637A6-0C93-45A5-6023-05C67B85A89F}"/>
          </ac:picMkLst>
        </pc:picChg>
        <pc:picChg chg="add del mod">
          <ac:chgData name="Maryam Vizheh" userId="35f18e4e-fdf0-440f-865e-c16e1aae76af" providerId="ADAL" clId="{3D4FC9FD-5B22-4007-AE11-03B0EEE6037B}" dt="2022-11-03T08:33:02.145" v="89" actId="478"/>
          <ac:picMkLst>
            <pc:docMk/>
            <pc:sldMk cId="1521863869" sldId="263"/>
            <ac:picMk id="7" creationId="{DE8EBA4F-19D6-BBB3-4AD2-1E8FBF1CBF92}"/>
          </ac:picMkLst>
        </pc:picChg>
        <pc:picChg chg="add del">
          <ac:chgData name="Maryam Vizheh" userId="35f18e4e-fdf0-440f-865e-c16e1aae76af" providerId="ADAL" clId="{3D4FC9FD-5B22-4007-AE11-03B0EEE6037B}" dt="2022-11-03T08:34:33.918" v="91" actId="22"/>
          <ac:picMkLst>
            <pc:docMk/>
            <pc:sldMk cId="1521863869" sldId="263"/>
            <ac:picMk id="9" creationId="{A7257F16-672E-CC9C-2F24-FFFD1154335E}"/>
          </ac:picMkLst>
        </pc:picChg>
        <pc:picChg chg="add mod">
          <ac:chgData name="Maryam Vizheh" userId="35f18e4e-fdf0-440f-865e-c16e1aae76af" providerId="ADAL" clId="{3D4FC9FD-5B22-4007-AE11-03B0EEE6037B}" dt="2022-11-03T08:55:18.041" v="115" actId="14100"/>
          <ac:picMkLst>
            <pc:docMk/>
            <pc:sldMk cId="1521863869" sldId="263"/>
            <ac:picMk id="11" creationId="{AAD8CC90-A56D-0FBB-E7D0-CBD8E0C9C35F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23:09.374" v="69" actId="14100"/>
        <pc:sldMkLst>
          <pc:docMk/>
          <pc:sldMk cId="3923914792" sldId="264"/>
        </pc:sldMkLst>
        <pc:spChg chg="mod">
          <ac:chgData name="Maryam Vizheh" userId="35f18e4e-fdf0-440f-865e-c16e1aae76af" providerId="ADAL" clId="{3D4FC9FD-5B22-4007-AE11-03B0EEE6037B}" dt="2022-11-03T08:23:01.105" v="68" actId="27636"/>
          <ac:spMkLst>
            <pc:docMk/>
            <pc:sldMk cId="3923914792" sldId="264"/>
            <ac:spMk id="2" creationId="{F9FC3AF9-64CB-A414-3F95-232ECF1B8BF1}"/>
          </ac:spMkLst>
        </pc:spChg>
        <pc:picChg chg="add del mod">
          <ac:chgData name="Maryam Vizheh" userId="35f18e4e-fdf0-440f-865e-c16e1aae76af" providerId="ADAL" clId="{3D4FC9FD-5B22-4007-AE11-03B0EEE6037B}" dt="2022-11-03T08:22:43.919" v="60" actId="478"/>
          <ac:picMkLst>
            <pc:docMk/>
            <pc:sldMk cId="3923914792" sldId="264"/>
            <ac:picMk id="4" creationId="{9928FEE6-48E9-6379-1B21-56619FC693DC}"/>
          </ac:picMkLst>
        </pc:picChg>
        <pc:picChg chg="del">
          <ac:chgData name="Maryam Vizheh" userId="35f18e4e-fdf0-440f-865e-c16e1aae76af" providerId="ADAL" clId="{3D4FC9FD-5B22-4007-AE11-03B0EEE6037B}" dt="2022-11-03T07:00:13.766" v="24" actId="478"/>
          <ac:picMkLst>
            <pc:docMk/>
            <pc:sldMk cId="3923914792" sldId="264"/>
            <ac:picMk id="5" creationId="{5A934ADD-F609-F553-C3A0-5F6C10B3EA1D}"/>
          </ac:picMkLst>
        </pc:picChg>
        <pc:picChg chg="add mod">
          <ac:chgData name="Maryam Vizheh" userId="35f18e4e-fdf0-440f-865e-c16e1aae76af" providerId="ADAL" clId="{3D4FC9FD-5B22-4007-AE11-03B0EEE6037B}" dt="2022-11-03T08:23:09.374" v="69" actId="14100"/>
          <ac:picMkLst>
            <pc:docMk/>
            <pc:sldMk cId="3923914792" sldId="264"/>
            <ac:picMk id="7" creationId="{64EAFAD2-7E3E-9E0F-82F2-A6A451ACA3FB}"/>
          </ac:picMkLst>
        </pc:picChg>
      </pc:sldChg>
      <pc:sldChg chg="addSp delSp modSp mod">
        <pc:chgData name="Maryam Vizheh" userId="35f18e4e-fdf0-440f-865e-c16e1aae76af" providerId="ADAL" clId="{3D4FC9FD-5B22-4007-AE11-03B0EEE6037B}" dt="2022-11-03T08:55:14.111" v="112" actId="14100"/>
        <pc:sldMkLst>
          <pc:docMk/>
          <pc:sldMk cId="2162717188" sldId="265"/>
        </pc:sldMkLst>
        <pc:spChg chg="mod">
          <ac:chgData name="Maryam Vizheh" userId="35f18e4e-fdf0-440f-865e-c16e1aae76af" providerId="ADAL" clId="{3D4FC9FD-5B22-4007-AE11-03B0EEE6037B}" dt="2022-11-03T08:55:05.624" v="108" actId="14100"/>
          <ac:spMkLst>
            <pc:docMk/>
            <pc:sldMk cId="2162717188" sldId="265"/>
            <ac:spMk id="2" creationId="{FA46C92B-C95F-5E56-7C1F-F223EC5217B0}"/>
          </ac:spMkLst>
        </pc:spChg>
        <pc:picChg chg="del">
          <ac:chgData name="Maryam Vizheh" userId="35f18e4e-fdf0-440f-865e-c16e1aae76af" providerId="ADAL" clId="{3D4FC9FD-5B22-4007-AE11-03B0EEE6037B}" dt="2022-11-03T07:00:15.322" v="25" actId="478"/>
          <ac:picMkLst>
            <pc:docMk/>
            <pc:sldMk cId="2162717188" sldId="265"/>
            <ac:picMk id="4" creationId="{C8907F93-7C18-A743-4A92-67EFC2EFD8C1}"/>
          </ac:picMkLst>
        </pc:picChg>
        <pc:picChg chg="add del">
          <ac:chgData name="Maryam Vizheh" userId="35f18e4e-fdf0-440f-865e-c16e1aae76af" providerId="ADAL" clId="{3D4FC9FD-5B22-4007-AE11-03B0EEE6037B}" dt="2022-11-03T08:25:32.889" v="71" actId="478"/>
          <ac:picMkLst>
            <pc:docMk/>
            <pc:sldMk cId="2162717188" sldId="265"/>
            <ac:picMk id="5" creationId="{6A6041E7-4DFD-EABE-ACB2-74E97831E1C8}"/>
          </ac:picMkLst>
        </pc:picChg>
        <pc:picChg chg="add del">
          <ac:chgData name="Maryam Vizheh" userId="35f18e4e-fdf0-440f-865e-c16e1aae76af" providerId="ADAL" clId="{3D4FC9FD-5B22-4007-AE11-03B0EEE6037B}" dt="2022-11-03T08:25:45.069" v="73" actId="478"/>
          <ac:picMkLst>
            <pc:docMk/>
            <pc:sldMk cId="2162717188" sldId="265"/>
            <ac:picMk id="7" creationId="{D2BE9659-4FA6-98CF-DF4B-16B1639BAA98}"/>
          </ac:picMkLst>
        </pc:picChg>
        <pc:picChg chg="add del mod">
          <ac:chgData name="Maryam Vizheh" userId="35f18e4e-fdf0-440f-865e-c16e1aae76af" providerId="ADAL" clId="{3D4FC9FD-5B22-4007-AE11-03B0EEE6037B}" dt="2022-11-03T08:29:16.037" v="84" actId="478"/>
          <ac:picMkLst>
            <pc:docMk/>
            <pc:sldMk cId="2162717188" sldId="265"/>
            <ac:picMk id="9" creationId="{B15FC01A-D0F6-B7A4-4BBF-3A4B228CC14D}"/>
          </ac:picMkLst>
        </pc:picChg>
        <pc:picChg chg="add del mod">
          <ac:chgData name="Maryam Vizheh" userId="35f18e4e-fdf0-440f-865e-c16e1aae76af" providerId="ADAL" clId="{3D4FC9FD-5B22-4007-AE11-03B0EEE6037B}" dt="2022-11-03T08:36:26.382" v="96" actId="478"/>
          <ac:picMkLst>
            <pc:docMk/>
            <pc:sldMk cId="2162717188" sldId="265"/>
            <ac:picMk id="11" creationId="{0223A304-89A9-B7EF-0127-DE5A37CDEFA7}"/>
          </ac:picMkLst>
        </pc:picChg>
        <pc:picChg chg="add mod">
          <ac:chgData name="Maryam Vizheh" userId="35f18e4e-fdf0-440f-865e-c16e1aae76af" providerId="ADAL" clId="{3D4FC9FD-5B22-4007-AE11-03B0EEE6037B}" dt="2022-11-03T08:55:14.111" v="112" actId="14100"/>
          <ac:picMkLst>
            <pc:docMk/>
            <pc:sldMk cId="2162717188" sldId="265"/>
            <ac:picMk id="13" creationId="{F67F05A1-A762-F9A9-5D55-BD1935C67DFB}"/>
          </ac:picMkLst>
        </pc:picChg>
      </pc:sldChg>
    </pc:docChg>
  </pc:docChgLst>
  <pc:docChgLst>
    <pc:chgData name="Maryam Vizheh" userId="35f18e4e-fdf0-440f-865e-c16e1aae76af" providerId="ADAL" clId="{92E3E596-7D80-4117-ADE5-E29F0BC8882A}"/>
    <pc:docChg chg="modSld">
      <pc:chgData name="Maryam Vizheh" userId="35f18e4e-fdf0-440f-865e-c16e1aae76af" providerId="ADAL" clId="{92E3E596-7D80-4117-ADE5-E29F0BC8882A}" dt="2023-02-01T03:41:15.552" v="47" actId="20577"/>
      <pc:docMkLst>
        <pc:docMk/>
      </pc:docMkLst>
      <pc:sldChg chg="modSp mod">
        <pc:chgData name="Maryam Vizheh" userId="35f18e4e-fdf0-440f-865e-c16e1aae76af" providerId="ADAL" clId="{92E3E596-7D80-4117-ADE5-E29F0BC8882A}" dt="2023-02-01T03:40:30.248" v="21" actId="20577"/>
        <pc:sldMkLst>
          <pc:docMk/>
          <pc:sldMk cId="1207130705" sldId="262"/>
        </pc:sldMkLst>
        <pc:spChg chg="mod">
          <ac:chgData name="Maryam Vizheh" userId="35f18e4e-fdf0-440f-865e-c16e1aae76af" providerId="ADAL" clId="{92E3E596-7D80-4117-ADE5-E29F0BC8882A}" dt="2023-02-01T03:40:30.248" v="21" actId="20577"/>
          <ac:spMkLst>
            <pc:docMk/>
            <pc:sldMk cId="1207130705" sldId="262"/>
            <ac:spMk id="2" creationId="{D00A587A-DCD8-ECEB-1C2A-4BCB666F43F9}"/>
          </ac:spMkLst>
        </pc:spChg>
      </pc:sldChg>
      <pc:sldChg chg="modSp mod">
        <pc:chgData name="Maryam Vizheh" userId="35f18e4e-fdf0-440f-865e-c16e1aae76af" providerId="ADAL" clId="{92E3E596-7D80-4117-ADE5-E29F0BC8882A}" dt="2023-02-01T03:40:48.776" v="38" actId="114"/>
        <pc:sldMkLst>
          <pc:docMk/>
          <pc:sldMk cId="1521863869" sldId="263"/>
        </pc:sldMkLst>
        <pc:spChg chg="mod">
          <ac:chgData name="Maryam Vizheh" userId="35f18e4e-fdf0-440f-865e-c16e1aae76af" providerId="ADAL" clId="{92E3E596-7D80-4117-ADE5-E29F0BC8882A}" dt="2023-02-01T03:40:48.776" v="38" actId="114"/>
          <ac:spMkLst>
            <pc:docMk/>
            <pc:sldMk cId="1521863869" sldId="263"/>
            <ac:spMk id="2" creationId="{F5FEE516-9510-0F4B-4F2C-888CA89C468C}"/>
          </ac:spMkLst>
        </pc:spChg>
      </pc:sldChg>
      <pc:sldChg chg="modSp mod">
        <pc:chgData name="Maryam Vizheh" userId="35f18e4e-fdf0-440f-865e-c16e1aae76af" providerId="ADAL" clId="{92E3E596-7D80-4117-ADE5-E29F0BC8882A}" dt="2023-02-01T03:41:15.552" v="47" actId="20577"/>
        <pc:sldMkLst>
          <pc:docMk/>
          <pc:sldMk cId="3923914792" sldId="264"/>
        </pc:sldMkLst>
        <pc:spChg chg="mod">
          <ac:chgData name="Maryam Vizheh" userId="35f18e4e-fdf0-440f-865e-c16e1aae76af" providerId="ADAL" clId="{92E3E596-7D80-4117-ADE5-E29F0BC8882A}" dt="2023-02-01T03:41:15.552" v="47" actId="20577"/>
          <ac:spMkLst>
            <pc:docMk/>
            <pc:sldMk cId="3923914792" sldId="264"/>
            <ac:spMk id="2" creationId="{F9FC3AF9-64CB-A414-3F95-232ECF1B8BF1}"/>
          </ac:spMkLst>
        </pc:spChg>
      </pc:sldChg>
    </pc:docChg>
  </pc:docChgLst>
  <pc:docChgLst>
    <pc:chgData name="Maryam Vizheh" userId="35f18e4e-fdf0-440f-865e-c16e1aae76af" providerId="ADAL" clId="{1C456EA3-6BAE-4D13-87B6-CC74FFD34F8F}"/>
    <pc:docChg chg="custSel modSld">
      <pc:chgData name="Maryam Vizheh" userId="35f18e4e-fdf0-440f-865e-c16e1aae76af" providerId="ADAL" clId="{1C456EA3-6BAE-4D13-87B6-CC74FFD34F8F}" dt="2023-02-22T12:45:02.148" v="39" actId="22"/>
      <pc:docMkLst>
        <pc:docMk/>
      </pc:docMkLst>
      <pc:sldChg chg="addSp delSp modSp mod">
        <pc:chgData name="Maryam Vizheh" userId="35f18e4e-fdf0-440f-865e-c16e1aae76af" providerId="ADAL" clId="{1C456EA3-6BAE-4D13-87B6-CC74FFD34F8F}" dt="2023-02-22T12:21:20.551" v="36" actId="27636"/>
        <pc:sldMkLst>
          <pc:docMk/>
          <pc:sldMk cId="407340889" sldId="259"/>
        </pc:sldMkLst>
        <pc:spChg chg="mod">
          <ac:chgData name="Maryam Vizheh" userId="35f18e4e-fdf0-440f-865e-c16e1aae76af" providerId="ADAL" clId="{1C456EA3-6BAE-4D13-87B6-CC74FFD34F8F}" dt="2023-02-22T12:21:20.551" v="36" actId="27636"/>
          <ac:spMkLst>
            <pc:docMk/>
            <pc:sldMk cId="407340889" sldId="259"/>
            <ac:spMk id="2" creationId="{1ECBB487-A7F1-0F8F-3BB9-79B8DD9AE87C}"/>
          </ac:spMkLst>
        </pc:spChg>
        <pc:picChg chg="add mod">
          <ac:chgData name="Maryam Vizheh" userId="35f18e4e-fdf0-440f-865e-c16e1aae76af" providerId="ADAL" clId="{1C456EA3-6BAE-4D13-87B6-CC74FFD34F8F}" dt="2023-02-22T12:19:47.735" v="6"/>
          <ac:picMkLst>
            <pc:docMk/>
            <pc:sldMk cId="407340889" sldId="259"/>
            <ac:picMk id="3" creationId="{AB4A89BD-7397-C8EB-8C9F-E8AC1C572187}"/>
          </ac:picMkLst>
        </pc:picChg>
        <pc:picChg chg="del mod">
          <ac:chgData name="Maryam Vizheh" userId="35f18e4e-fdf0-440f-865e-c16e1aae76af" providerId="ADAL" clId="{1C456EA3-6BAE-4D13-87B6-CC74FFD34F8F}" dt="2023-02-22T12:19:45.799" v="5" actId="478"/>
          <ac:picMkLst>
            <pc:docMk/>
            <pc:sldMk cId="407340889" sldId="259"/>
            <ac:picMk id="6" creationId="{0BD810BE-C7FB-1EC8-120F-A29B3D105FAE}"/>
          </ac:picMkLst>
        </pc:picChg>
      </pc:sldChg>
      <pc:sldChg chg="addSp delSp mod">
        <pc:chgData name="Maryam Vizheh" userId="35f18e4e-fdf0-440f-865e-c16e1aae76af" providerId="ADAL" clId="{1C456EA3-6BAE-4D13-87B6-CC74FFD34F8F}" dt="2023-02-22T11:51:26.877" v="2" actId="22"/>
        <pc:sldMkLst>
          <pc:docMk/>
          <pc:sldMk cId="1521863869" sldId="263"/>
        </pc:sldMkLst>
        <pc:picChg chg="add">
          <ac:chgData name="Maryam Vizheh" userId="35f18e4e-fdf0-440f-865e-c16e1aae76af" providerId="ADAL" clId="{1C456EA3-6BAE-4D13-87B6-CC74FFD34F8F}" dt="2023-02-22T11:51:26.877" v="2" actId="22"/>
          <ac:picMkLst>
            <pc:docMk/>
            <pc:sldMk cId="1521863869" sldId="263"/>
            <ac:picMk id="4" creationId="{3CDB1769-E651-8DDC-4391-6608F11D8099}"/>
          </ac:picMkLst>
        </pc:picChg>
        <pc:picChg chg="del">
          <ac:chgData name="Maryam Vizheh" userId="35f18e4e-fdf0-440f-865e-c16e1aae76af" providerId="ADAL" clId="{1C456EA3-6BAE-4D13-87B6-CC74FFD34F8F}" dt="2023-02-22T11:51:21.695" v="1" actId="478"/>
          <ac:picMkLst>
            <pc:docMk/>
            <pc:sldMk cId="1521863869" sldId="263"/>
            <ac:picMk id="11" creationId="{AAD8CC90-A56D-0FBB-E7D0-CBD8E0C9C35F}"/>
          </ac:picMkLst>
        </pc:picChg>
      </pc:sldChg>
      <pc:sldChg chg="addSp delSp modSp mod">
        <pc:chgData name="Maryam Vizheh" userId="35f18e4e-fdf0-440f-865e-c16e1aae76af" providerId="ADAL" clId="{1C456EA3-6BAE-4D13-87B6-CC74FFD34F8F}" dt="2023-02-22T12:45:02.148" v="39" actId="22"/>
        <pc:sldMkLst>
          <pc:docMk/>
          <pc:sldMk cId="2162717188" sldId="265"/>
        </pc:sldMkLst>
        <pc:spChg chg="mod">
          <ac:chgData name="Maryam Vizheh" userId="35f18e4e-fdf0-440f-865e-c16e1aae76af" providerId="ADAL" clId="{1C456EA3-6BAE-4D13-87B6-CC74FFD34F8F}" dt="2023-02-22T12:24:01.476" v="38"/>
          <ac:spMkLst>
            <pc:docMk/>
            <pc:sldMk cId="2162717188" sldId="265"/>
            <ac:spMk id="2" creationId="{FA46C92B-C95F-5E56-7C1F-F223EC5217B0}"/>
          </ac:spMkLst>
        </pc:spChg>
        <pc:picChg chg="add del">
          <ac:chgData name="Maryam Vizheh" userId="35f18e4e-fdf0-440f-865e-c16e1aae76af" providerId="ADAL" clId="{1C456EA3-6BAE-4D13-87B6-CC74FFD34F8F}" dt="2023-02-22T12:23:58.046" v="37" actId="478"/>
          <ac:picMkLst>
            <pc:docMk/>
            <pc:sldMk cId="2162717188" sldId="265"/>
            <ac:picMk id="4" creationId="{9C90AC68-A8DC-8E7C-DBD5-6AB49284C86C}"/>
          </ac:picMkLst>
        </pc:picChg>
        <pc:picChg chg="add">
          <ac:chgData name="Maryam Vizheh" userId="35f18e4e-fdf0-440f-865e-c16e1aae76af" providerId="ADAL" clId="{1C456EA3-6BAE-4D13-87B6-CC74FFD34F8F}" dt="2023-02-22T12:45:02.148" v="39" actId="22"/>
          <ac:picMkLst>
            <pc:docMk/>
            <pc:sldMk cId="2162717188" sldId="265"/>
            <ac:picMk id="6" creationId="{F2175888-21FF-93CD-2E7D-3DCE066B55F3}"/>
          </ac:picMkLst>
        </pc:picChg>
        <pc:picChg chg="del">
          <ac:chgData name="Maryam Vizheh" userId="35f18e4e-fdf0-440f-865e-c16e1aae76af" providerId="ADAL" clId="{1C456EA3-6BAE-4D13-87B6-CC74FFD34F8F}" dt="2023-02-22T11:56:46.333" v="3" actId="478"/>
          <ac:picMkLst>
            <pc:docMk/>
            <pc:sldMk cId="2162717188" sldId="265"/>
            <ac:picMk id="13" creationId="{F67F05A1-A762-F9A9-5D55-BD1935C67DFB}"/>
          </ac:picMkLst>
        </pc:picChg>
      </pc:sldChg>
    </pc:docChg>
  </pc:docChgLst>
  <pc:docChgLst>
    <pc:chgData name="Maryam Vizheh" userId="35f18e4e-fdf0-440f-865e-c16e1aae76af" providerId="ADAL" clId="{912909B9-1813-427E-8FD6-D0AB40E7FF9E}"/>
    <pc:docChg chg="undo custSel modSld">
      <pc:chgData name="Maryam Vizheh" userId="35f18e4e-fdf0-440f-865e-c16e1aae76af" providerId="ADAL" clId="{912909B9-1813-427E-8FD6-D0AB40E7FF9E}" dt="2022-11-28T04:31:29.950" v="6" actId="1076"/>
      <pc:docMkLst>
        <pc:docMk/>
      </pc:docMkLst>
      <pc:sldChg chg="modSp mod">
        <pc:chgData name="Maryam Vizheh" userId="35f18e4e-fdf0-440f-865e-c16e1aae76af" providerId="ADAL" clId="{912909B9-1813-427E-8FD6-D0AB40E7FF9E}" dt="2022-11-28T04:31:29.950" v="6" actId="1076"/>
        <pc:sldMkLst>
          <pc:docMk/>
          <pc:sldMk cId="1521863869" sldId="263"/>
        </pc:sldMkLst>
        <pc:picChg chg="mod">
          <ac:chgData name="Maryam Vizheh" userId="35f18e4e-fdf0-440f-865e-c16e1aae76af" providerId="ADAL" clId="{912909B9-1813-427E-8FD6-D0AB40E7FF9E}" dt="2022-11-28T04:31:29.950" v="6" actId="1076"/>
          <ac:picMkLst>
            <pc:docMk/>
            <pc:sldMk cId="1521863869" sldId="263"/>
            <ac:picMk id="11" creationId="{AAD8CC90-A56D-0FBB-E7D0-CBD8E0C9C35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6347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3805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4646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22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8489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0465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7375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6165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19041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6414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94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5FCA5-3324-4896-AFBE-CED3156E5915}" type="datetimeFigureOut">
              <a:rPr lang="en-AU" smtClean="0"/>
              <a:t>23/02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8473D-8262-467C-BB76-CED486357C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4111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AA7AEF-1135-460E-647F-5E6D0A1B978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pPr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35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Impact of Women’s Agency on Accessing and Using Maternal Healthcare Services; a Systematic review and Meta-analysis</a:t>
            </a:r>
            <a:br>
              <a:rPr lang="en-AU" sz="135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AU" sz="135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ECDEAB-4E8F-62EE-DEB0-28D9B1ED227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s of sub-group analysis</a:t>
            </a:r>
          </a:p>
          <a:p>
            <a:endParaRPr lang="en-US" b="1" dirty="0">
              <a:latin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163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24DD9F24-D123-4606-CACA-A485D51D9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3740" y="133565"/>
            <a:ext cx="2085752" cy="2137023"/>
          </a:xfrm>
        </p:spPr>
        <p:txBody>
          <a:bodyPr>
            <a:norm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. 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</a:rPr>
              <a:t>Forest plot of the association between various dimensions of </a:t>
            </a:r>
            <a:r>
              <a:rPr lang="en-AU" sz="1350" dirty="0">
                <a:latin typeface="Times New Roman" panose="02020603050405020304" pitchFamily="18" charset="0"/>
                <a:ea typeface="Calibri" panose="020F0502020204030204" pitchFamily="34" charset="0"/>
              </a:rPr>
              <a:t>women’s agency and</a:t>
            </a:r>
            <a:r>
              <a:rPr lang="en-AU" sz="135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</a:rPr>
              <a:t>skilled ANC</a:t>
            </a:r>
            <a:endParaRPr lang="en-AU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C13FA54-C5AA-EA8D-9E05-39FA691CDC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3952" y="0"/>
            <a:ext cx="671004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0361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BB912-97C3-FA27-116A-B4F699E33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919" y="400692"/>
            <a:ext cx="2825393" cy="1325563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2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iming of the first ANC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E9E6D5-8956-31C8-7303-38173CD8B4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2888" y="0"/>
            <a:ext cx="620156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9331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A587A-DCD8-ECEB-1C2A-4BCB666F43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008" y="0"/>
            <a:ext cx="9015984" cy="1325563"/>
          </a:xfrm>
        </p:spPr>
        <p:txBody>
          <a:bodyPr>
            <a:norm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t least one ANC visit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A2CDD76-3C1D-A5F3-141A-070C3729A5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1803" y="767366"/>
            <a:ext cx="7335747" cy="57342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71307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EE516-9510-0F4B-4F2C-888CA89C46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22286" y="60018"/>
            <a:ext cx="4594286" cy="1624943"/>
          </a:xfrm>
        </p:spPr>
        <p:txBody>
          <a:bodyPr>
            <a:norm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ore than four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C visits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DB1769-E651-8DDC-4391-6608F11D80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1304" y="1597152"/>
            <a:ext cx="5041392" cy="366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18638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C3AF9-64CB-A414-3F95-232ECF1B8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4708" y="734855"/>
            <a:ext cx="2597919" cy="2272296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5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ore than eight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C visits</a:t>
            </a:r>
            <a:b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AU" sz="13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4EAFAD2-7E3E-9E0F-82F2-A6A451ACA3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1840" y="207389"/>
            <a:ext cx="5852160" cy="6650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39147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46C92B-C95F-5E56-7C1F-F223EC521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4380" y="385011"/>
            <a:ext cx="4572000" cy="1325563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6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cility-based delivery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2175888-21FF-93CD-2E7D-3DCE066B55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1304" y="1597152"/>
            <a:ext cx="5041392" cy="366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27171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BB487-A7F1-0F8F-3BB9-79B8DD9AE8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1027" y="365126"/>
            <a:ext cx="5885700" cy="1325563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7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 skilled birth attendants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B4A89BD-7397-C8EB-8C9F-E8AC1C5721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5304" y="1597152"/>
            <a:ext cx="5041392" cy="366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3408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694B5-E4BD-99EA-EE97-108512C04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4676" y="365126"/>
            <a:ext cx="4471916" cy="1325563"/>
          </a:xfrm>
        </p:spPr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8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 of the association between various dimensions of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men’s agency and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NC</a:t>
            </a:r>
            <a:b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AU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575345C-D148-D3EA-1FB9-76FA79A776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1304" y="1597152"/>
            <a:ext cx="5440166" cy="4704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9540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82c514c1-a717-4087-be06-d40d2070ad52}" enabled="0" method="" siteId="{82c514c1-a717-4087-be06-d40d2070ad5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</TotalTime>
  <Words>183</Words>
  <Application>Microsoft Office PowerPoint</Application>
  <PresentationFormat>On-screen Show (4:3)</PresentationFormat>
  <Paragraphs>1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Palatino Linotype</vt:lpstr>
      <vt:lpstr>Times New Roman</vt:lpstr>
      <vt:lpstr>Office Theme</vt:lpstr>
      <vt:lpstr>The Impact of Women’s Agency on Accessing and Using Maternal Healthcare Services; a Systematic review and Meta-analysis  </vt:lpstr>
      <vt:lpstr>Figure S1. Forest plot of the association between various dimensions of women’s agency and skilled ANC</vt:lpstr>
      <vt:lpstr>Figure S2. Forest plot of the association between various dimensions of women’s agency and timing of the first ANC </vt:lpstr>
      <vt:lpstr>Figure S3. Forest plot of the association between various dimensions of women’s agency and at least one ANC visit </vt:lpstr>
      <vt:lpstr>Figure S4. Forest plot of the association between various dimensions of women’s agency and more than four ANC visits </vt:lpstr>
      <vt:lpstr>Figure S5. Forest plot of the association between various dimensions of women’s agency and more than eight ANC visits   </vt:lpstr>
      <vt:lpstr>Figure S6. Forest plot of the association between various dimensions of women’s agency and facility-based delivery </vt:lpstr>
      <vt:lpstr>Figure S7. Forest plot of the association between various dimensions of women’s agency and using skilled birth attendants </vt:lpstr>
      <vt:lpstr>Figure S8. Forest plot of the association between various dimensions of women’s agency and PNC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ystematic literature review and Meta-analysis of the Impact of Women’s Agency on Accessing and Using Maternal Healthcare Services  </dc:title>
  <dc:creator>Maryam Vizheh</dc:creator>
  <cp:lastModifiedBy>MDPI</cp:lastModifiedBy>
  <cp:revision>2</cp:revision>
  <dcterms:created xsi:type="dcterms:W3CDTF">2022-10-03T09:17:02Z</dcterms:created>
  <dcterms:modified xsi:type="dcterms:W3CDTF">2023-02-23T07:43:04Z</dcterms:modified>
</cp:coreProperties>
</file>